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8" d="100"/>
          <a:sy n="68" d="100"/>
        </p:scale>
        <p:origin x="58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se Denoeud" userId="2ae5119a-4b99-4d54-9205-1fb18db3d132" providerId="ADAL" clId="{4460F774-F5B1-487C-9FCE-A950DAD9F418}"/>
    <pc:docChg chg="custSel modSld">
      <pc:chgData name="Lise Denoeud" userId="2ae5119a-4b99-4d54-9205-1fb18db3d132" providerId="ADAL" clId="{4460F774-F5B1-487C-9FCE-A950DAD9F418}" dt="2022-10-27T16:05:11.815" v="96" actId="1037"/>
      <pc:docMkLst>
        <pc:docMk/>
      </pc:docMkLst>
      <pc:sldChg chg="modSp">
        <pc:chgData name="Lise Denoeud" userId="2ae5119a-4b99-4d54-9205-1fb18db3d132" providerId="ADAL" clId="{4460F774-F5B1-487C-9FCE-A950DAD9F418}" dt="2022-10-27T16:05:11.815" v="96" actId="1037"/>
        <pc:sldMkLst>
          <pc:docMk/>
          <pc:sldMk cId="1432623817" sldId="256"/>
        </pc:sldMkLst>
        <pc:spChg chg="mod">
          <ac:chgData name="Lise Denoeud" userId="2ae5119a-4b99-4d54-9205-1fb18db3d132" providerId="ADAL" clId="{4460F774-F5B1-487C-9FCE-A950DAD9F418}" dt="2022-10-27T16:05:11.815" v="96" actId="1037"/>
          <ac:spMkLst>
            <pc:docMk/>
            <pc:sldMk cId="1432623817" sldId="256"/>
            <ac:spMk id="4" creationId="{D13E8827-6AF7-4052-A99C-721C96F21DBC}"/>
          </ac:spMkLst>
        </pc:spChg>
        <pc:spChg chg="mod">
          <ac:chgData name="Lise Denoeud" userId="2ae5119a-4b99-4d54-9205-1fb18db3d132" providerId="ADAL" clId="{4460F774-F5B1-487C-9FCE-A950DAD9F418}" dt="2022-10-27T16:05:11.815" v="96" actId="1037"/>
          <ac:spMkLst>
            <pc:docMk/>
            <pc:sldMk cId="1432623817" sldId="256"/>
            <ac:spMk id="5" creationId="{52F13B4F-E9DE-4972-89AD-0EF96656586D}"/>
          </ac:spMkLst>
        </pc:spChg>
        <pc:spChg chg="mod">
          <ac:chgData name="Lise Denoeud" userId="2ae5119a-4b99-4d54-9205-1fb18db3d132" providerId="ADAL" clId="{4460F774-F5B1-487C-9FCE-A950DAD9F418}" dt="2022-10-27T16:05:11.815" v="96" actId="1037"/>
          <ac:spMkLst>
            <pc:docMk/>
            <pc:sldMk cId="1432623817" sldId="256"/>
            <ac:spMk id="6" creationId="{7167C8C2-10A1-4BBE-963F-A60764812273}"/>
          </ac:spMkLst>
        </pc:spChg>
        <pc:spChg chg="mod">
          <ac:chgData name="Lise Denoeud" userId="2ae5119a-4b99-4d54-9205-1fb18db3d132" providerId="ADAL" clId="{4460F774-F5B1-487C-9FCE-A950DAD9F418}" dt="2022-10-27T16:05:11.815" v="96" actId="1037"/>
          <ac:spMkLst>
            <pc:docMk/>
            <pc:sldMk cId="1432623817" sldId="256"/>
            <ac:spMk id="7" creationId="{46F95602-531B-49C4-8EEA-004C788006A1}"/>
          </ac:spMkLst>
        </pc:spChg>
        <pc:spChg chg="mod">
          <ac:chgData name="Lise Denoeud" userId="2ae5119a-4b99-4d54-9205-1fb18db3d132" providerId="ADAL" clId="{4460F774-F5B1-487C-9FCE-A950DAD9F418}" dt="2022-10-27T16:05:11.815" v="96" actId="1037"/>
          <ac:spMkLst>
            <pc:docMk/>
            <pc:sldMk cId="1432623817" sldId="256"/>
            <ac:spMk id="8" creationId="{E16C00CA-F73B-4709-A3EC-56332F9B9E2E}"/>
          </ac:spMkLst>
        </pc:spChg>
        <pc:spChg chg="mod">
          <ac:chgData name="Lise Denoeud" userId="2ae5119a-4b99-4d54-9205-1fb18db3d132" providerId="ADAL" clId="{4460F774-F5B1-487C-9FCE-A950DAD9F418}" dt="2022-10-27T16:05:11.815" v="96" actId="1037"/>
          <ac:spMkLst>
            <pc:docMk/>
            <pc:sldMk cId="1432623817" sldId="256"/>
            <ac:spMk id="9" creationId="{DE9DCA5A-2C2B-41F7-8449-BBB3FE1BF10B}"/>
          </ac:spMkLst>
        </pc:spChg>
        <pc:spChg chg="mod">
          <ac:chgData name="Lise Denoeud" userId="2ae5119a-4b99-4d54-9205-1fb18db3d132" providerId="ADAL" clId="{4460F774-F5B1-487C-9FCE-A950DAD9F418}" dt="2022-10-27T16:05:11.815" v="96" actId="1037"/>
          <ac:spMkLst>
            <pc:docMk/>
            <pc:sldMk cId="1432623817" sldId="256"/>
            <ac:spMk id="10" creationId="{008E08BA-A59C-4F75-8633-781C036E7249}"/>
          </ac:spMkLst>
        </pc:spChg>
        <pc:cxnChg chg="mod">
          <ac:chgData name="Lise Denoeud" userId="2ae5119a-4b99-4d54-9205-1fb18db3d132" providerId="ADAL" clId="{4460F774-F5B1-487C-9FCE-A950DAD9F418}" dt="2022-10-27T16:05:11.815" v="96" actId="1037"/>
          <ac:cxnSpMkLst>
            <pc:docMk/>
            <pc:sldMk cId="1432623817" sldId="256"/>
            <ac:cxnSpMk id="14" creationId="{95E4544F-7523-4F54-BF09-8B3D5A1A8FAC}"/>
          </ac:cxnSpMkLst>
        </pc:cxnChg>
        <pc:cxnChg chg="mod">
          <ac:chgData name="Lise Denoeud" userId="2ae5119a-4b99-4d54-9205-1fb18db3d132" providerId="ADAL" clId="{4460F774-F5B1-487C-9FCE-A950DAD9F418}" dt="2022-10-27T16:05:11.815" v="96" actId="1037"/>
          <ac:cxnSpMkLst>
            <pc:docMk/>
            <pc:sldMk cId="1432623817" sldId="256"/>
            <ac:cxnSpMk id="22" creationId="{D77782D4-881F-4B94-8B32-6403807E74D8}"/>
          </ac:cxnSpMkLst>
        </pc:cxnChg>
        <pc:cxnChg chg="mod">
          <ac:chgData name="Lise Denoeud" userId="2ae5119a-4b99-4d54-9205-1fb18db3d132" providerId="ADAL" clId="{4460F774-F5B1-487C-9FCE-A950DAD9F418}" dt="2022-10-27T16:05:11.815" v="96" actId="1037"/>
          <ac:cxnSpMkLst>
            <pc:docMk/>
            <pc:sldMk cId="1432623817" sldId="256"/>
            <ac:cxnSpMk id="28" creationId="{6EFAEDA9-97F6-4F9F-9A32-A24DB6C4911A}"/>
          </ac:cxnSpMkLst>
        </pc:cxnChg>
        <pc:cxnChg chg="mod">
          <ac:chgData name="Lise Denoeud" userId="2ae5119a-4b99-4d54-9205-1fb18db3d132" providerId="ADAL" clId="{4460F774-F5B1-487C-9FCE-A950DAD9F418}" dt="2022-10-27T16:05:11.815" v="96" actId="1037"/>
          <ac:cxnSpMkLst>
            <pc:docMk/>
            <pc:sldMk cId="1432623817" sldId="256"/>
            <ac:cxnSpMk id="30" creationId="{D5683480-6363-46BA-87D3-48B7D1A8112B}"/>
          </ac:cxnSpMkLst>
        </pc:cxnChg>
        <pc:cxnChg chg="mod">
          <ac:chgData name="Lise Denoeud" userId="2ae5119a-4b99-4d54-9205-1fb18db3d132" providerId="ADAL" clId="{4460F774-F5B1-487C-9FCE-A950DAD9F418}" dt="2022-10-27T16:05:11.815" v="96" actId="1037"/>
          <ac:cxnSpMkLst>
            <pc:docMk/>
            <pc:sldMk cId="1432623817" sldId="256"/>
            <ac:cxnSpMk id="32" creationId="{5DDC0D79-926B-4C3F-91DE-82F933F1556D}"/>
          </ac:cxnSpMkLst>
        </pc:cxnChg>
        <pc:cxnChg chg="mod">
          <ac:chgData name="Lise Denoeud" userId="2ae5119a-4b99-4d54-9205-1fb18db3d132" providerId="ADAL" clId="{4460F774-F5B1-487C-9FCE-A950DAD9F418}" dt="2022-10-27T16:05:11.815" v="96" actId="1037"/>
          <ac:cxnSpMkLst>
            <pc:docMk/>
            <pc:sldMk cId="1432623817" sldId="256"/>
            <ac:cxnSpMk id="53" creationId="{1E6B1159-768D-4EFB-84C3-D89F05387384}"/>
          </ac:cxnSpMkLst>
        </pc:cxnChg>
      </pc:sldChg>
    </pc:docChg>
  </pc:docChgLst>
  <pc:docChgLst>
    <pc:chgData name="Lise Denoeud" userId="2ae5119a-4b99-4d54-9205-1fb18db3d132" providerId="ADAL" clId="{FC7DF5A0-6F98-4166-9574-1EC73A50F3A5}"/>
    <pc:docChg chg="custSel addSld delSld modSld">
      <pc:chgData name="Lise Denoeud" userId="2ae5119a-4b99-4d54-9205-1fb18db3d132" providerId="ADAL" clId="{FC7DF5A0-6F98-4166-9574-1EC73A50F3A5}" dt="2022-12-07T09:45:40.033" v="197" actId="113"/>
      <pc:docMkLst>
        <pc:docMk/>
      </pc:docMkLst>
      <pc:sldChg chg="addSp delSp modSp">
        <pc:chgData name="Lise Denoeud" userId="2ae5119a-4b99-4d54-9205-1fb18db3d132" providerId="ADAL" clId="{FC7DF5A0-6F98-4166-9574-1EC73A50F3A5}" dt="2022-12-07T09:45:40.033" v="197" actId="113"/>
        <pc:sldMkLst>
          <pc:docMk/>
          <pc:sldMk cId="1432623817" sldId="256"/>
        </pc:sldMkLst>
        <pc:spChg chg="add mod">
          <ac:chgData name="Lise Denoeud" userId="2ae5119a-4b99-4d54-9205-1fb18db3d132" providerId="ADAL" clId="{FC7DF5A0-6F98-4166-9574-1EC73A50F3A5}" dt="2022-12-07T09:45:40.033" v="197" actId="113"/>
          <ac:spMkLst>
            <pc:docMk/>
            <pc:sldMk cId="1432623817" sldId="256"/>
            <ac:spMk id="2" creationId="{35EFC873-B0AD-4CED-81C8-B8A6B6ED3A05}"/>
          </ac:spMkLst>
        </pc:spChg>
        <pc:spChg chg="mod">
          <ac:chgData name="Lise Denoeud" userId="2ae5119a-4b99-4d54-9205-1fb18db3d132" providerId="ADAL" clId="{FC7DF5A0-6F98-4166-9574-1EC73A50F3A5}" dt="2022-12-07T09:17:03.845" v="181" actId="1036"/>
          <ac:spMkLst>
            <pc:docMk/>
            <pc:sldMk cId="1432623817" sldId="256"/>
            <ac:spMk id="4" creationId="{D13E8827-6AF7-4052-A99C-721C96F21DBC}"/>
          </ac:spMkLst>
        </pc:spChg>
        <pc:spChg chg="mod">
          <ac:chgData name="Lise Denoeud" userId="2ae5119a-4b99-4d54-9205-1fb18db3d132" providerId="ADAL" clId="{FC7DF5A0-6F98-4166-9574-1EC73A50F3A5}" dt="2022-12-07T09:17:03.845" v="181" actId="1036"/>
          <ac:spMkLst>
            <pc:docMk/>
            <pc:sldMk cId="1432623817" sldId="256"/>
            <ac:spMk id="5" creationId="{52F13B4F-E9DE-4972-89AD-0EF96656586D}"/>
          </ac:spMkLst>
        </pc:spChg>
        <pc:spChg chg="mod">
          <ac:chgData name="Lise Denoeud" userId="2ae5119a-4b99-4d54-9205-1fb18db3d132" providerId="ADAL" clId="{FC7DF5A0-6F98-4166-9574-1EC73A50F3A5}" dt="2022-12-07T09:17:03.845" v="181" actId="1036"/>
          <ac:spMkLst>
            <pc:docMk/>
            <pc:sldMk cId="1432623817" sldId="256"/>
            <ac:spMk id="6" creationId="{7167C8C2-10A1-4BBE-963F-A60764812273}"/>
          </ac:spMkLst>
        </pc:spChg>
        <pc:spChg chg="mod">
          <ac:chgData name="Lise Denoeud" userId="2ae5119a-4b99-4d54-9205-1fb18db3d132" providerId="ADAL" clId="{FC7DF5A0-6F98-4166-9574-1EC73A50F3A5}" dt="2022-12-07T09:17:03.845" v="181" actId="1036"/>
          <ac:spMkLst>
            <pc:docMk/>
            <pc:sldMk cId="1432623817" sldId="256"/>
            <ac:spMk id="7" creationId="{46F95602-531B-49C4-8EEA-004C788006A1}"/>
          </ac:spMkLst>
        </pc:spChg>
        <pc:spChg chg="mod">
          <ac:chgData name="Lise Denoeud" userId="2ae5119a-4b99-4d54-9205-1fb18db3d132" providerId="ADAL" clId="{FC7DF5A0-6F98-4166-9574-1EC73A50F3A5}" dt="2022-12-07T09:17:03.845" v="181" actId="1036"/>
          <ac:spMkLst>
            <pc:docMk/>
            <pc:sldMk cId="1432623817" sldId="256"/>
            <ac:spMk id="8" creationId="{E16C00CA-F73B-4709-A3EC-56332F9B9E2E}"/>
          </ac:spMkLst>
        </pc:spChg>
        <pc:spChg chg="mod">
          <ac:chgData name="Lise Denoeud" userId="2ae5119a-4b99-4d54-9205-1fb18db3d132" providerId="ADAL" clId="{FC7DF5A0-6F98-4166-9574-1EC73A50F3A5}" dt="2022-12-07T09:17:03.845" v="181" actId="1036"/>
          <ac:spMkLst>
            <pc:docMk/>
            <pc:sldMk cId="1432623817" sldId="256"/>
            <ac:spMk id="9" creationId="{DE9DCA5A-2C2B-41F7-8449-BBB3FE1BF10B}"/>
          </ac:spMkLst>
        </pc:spChg>
        <pc:spChg chg="mod">
          <ac:chgData name="Lise Denoeud" userId="2ae5119a-4b99-4d54-9205-1fb18db3d132" providerId="ADAL" clId="{FC7DF5A0-6F98-4166-9574-1EC73A50F3A5}" dt="2022-12-07T09:17:03.845" v="181" actId="1036"/>
          <ac:spMkLst>
            <pc:docMk/>
            <pc:sldMk cId="1432623817" sldId="256"/>
            <ac:spMk id="10" creationId="{008E08BA-A59C-4F75-8633-781C036E7249}"/>
          </ac:spMkLst>
        </pc:spChg>
        <pc:spChg chg="add del mod">
          <ac:chgData name="Lise Denoeud" userId="2ae5119a-4b99-4d54-9205-1fb18db3d132" providerId="ADAL" clId="{FC7DF5A0-6F98-4166-9574-1EC73A50F3A5}" dt="2022-12-07T09:45:27.640" v="196" actId="478"/>
          <ac:spMkLst>
            <pc:docMk/>
            <pc:sldMk cId="1432623817" sldId="256"/>
            <ac:spMk id="16" creationId="{1D2382DB-45B1-4919-AC73-5A62D19B892A}"/>
          </ac:spMkLst>
        </pc:spChg>
        <pc:cxnChg chg="mod">
          <ac:chgData name="Lise Denoeud" userId="2ae5119a-4b99-4d54-9205-1fb18db3d132" providerId="ADAL" clId="{FC7DF5A0-6F98-4166-9574-1EC73A50F3A5}" dt="2022-12-07T09:17:03.845" v="181" actId="1036"/>
          <ac:cxnSpMkLst>
            <pc:docMk/>
            <pc:sldMk cId="1432623817" sldId="256"/>
            <ac:cxnSpMk id="14" creationId="{95E4544F-7523-4F54-BF09-8B3D5A1A8FAC}"/>
          </ac:cxnSpMkLst>
        </pc:cxnChg>
        <pc:cxnChg chg="mod">
          <ac:chgData name="Lise Denoeud" userId="2ae5119a-4b99-4d54-9205-1fb18db3d132" providerId="ADAL" clId="{FC7DF5A0-6F98-4166-9574-1EC73A50F3A5}" dt="2022-12-07T09:17:03.845" v="181" actId="1036"/>
          <ac:cxnSpMkLst>
            <pc:docMk/>
            <pc:sldMk cId="1432623817" sldId="256"/>
            <ac:cxnSpMk id="22" creationId="{D77782D4-881F-4B94-8B32-6403807E74D8}"/>
          </ac:cxnSpMkLst>
        </pc:cxnChg>
        <pc:cxnChg chg="mod">
          <ac:chgData name="Lise Denoeud" userId="2ae5119a-4b99-4d54-9205-1fb18db3d132" providerId="ADAL" clId="{FC7DF5A0-6F98-4166-9574-1EC73A50F3A5}" dt="2022-12-07T09:17:03.845" v="181" actId="1036"/>
          <ac:cxnSpMkLst>
            <pc:docMk/>
            <pc:sldMk cId="1432623817" sldId="256"/>
            <ac:cxnSpMk id="28" creationId="{6EFAEDA9-97F6-4F9F-9A32-A24DB6C4911A}"/>
          </ac:cxnSpMkLst>
        </pc:cxnChg>
        <pc:cxnChg chg="mod">
          <ac:chgData name="Lise Denoeud" userId="2ae5119a-4b99-4d54-9205-1fb18db3d132" providerId="ADAL" clId="{FC7DF5A0-6F98-4166-9574-1EC73A50F3A5}" dt="2022-12-07T09:17:03.845" v="181" actId="1036"/>
          <ac:cxnSpMkLst>
            <pc:docMk/>
            <pc:sldMk cId="1432623817" sldId="256"/>
            <ac:cxnSpMk id="30" creationId="{D5683480-6363-46BA-87D3-48B7D1A8112B}"/>
          </ac:cxnSpMkLst>
        </pc:cxnChg>
        <pc:cxnChg chg="mod">
          <ac:chgData name="Lise Denoeud" userId="2ae5119a-4b99-4d54-9205-1fb18db3d132" providerId="ADAL" clId="{FC7DF5A0-6F98-4166-9574-1EC73A50F3A5}" dt="2022-12-07T09:17:03.845" v="181" actId="1036"/>
          <ac:cxnSpMkLst>
            <pc:docMk/>
            <pc:sldMk cId="1432623817" sldId="256"/>
            <ac:cxnSpMk id="32" creationId="{5DDC0D79-926B-4C3F-91DE-82F933F1556D}"/>
          </ac:cxnSpMkLst>
        </pc:cxnChg>
        <pc:cxnChg chg="mod">
          <ac:chgData name="Lise Denoeud" userId="2ae5119a-4b99-4d54-9205-1fb18db3d132" providerId="ADAL" clId="{FC7DF5A0-6F98-4166-9574-1EC73A50F3A5}" dt="2022-12-07T09:17:03.845" v="181" actId="1036"/>
          <ac:cxnSpMkLst>
            <pc:docMk/>
            <pc:sldMk cId="1432623817" sldId="256"/>
            <ac:cxnSpMk id="53" creationId="{1E6B1159-768D-4EFB-84C3-D89F05387384}"/>
          </ac:cxnSpMkLst>
        </pc:cxnChg>
      </pc:sldChg>
      <pc:sldChg chg="addSp delSp modSp add del">
        <pc:chgData name="Lise Denoeud" userId="2ae5119a-4b99-4d54-9205-1fb18db3d132" providerId="ADAL" clId="{FC7DF5A0-6F98-4166-9574-1EC73A50F3A5}" dt="2022-12-07T09:18:27.720" v="193" actId="2696"/>
        <pc:sldMkLst>
          <pc:docMk/>
          <pc:sldMk cId="724398003" sldId="257"/>
        </pc:sldMkLst>
        <pc:spChg chg="del">
          <ac:chgData name="Lise Denoeud" userId="2ae5119a-4b99-4d54-9205-1fb18db3d132" providerId="ADAL" clId="{FC7DF5A0-6F98-4166-9574-1EC73A50F3A5}" dt="2022-12-07T09:15:29.153" v="10" actId="478"/>
          <ac:spMkLst>
            <pc:docMk/>
            <pc:sldMk cId="724398003" sldId="257"/>
            <ac:spMk id="2" creationId="{5C90FC95-1560-4CC7-8F5C-E44066180EE5}"/>
          </ac:spMkLst>
        </pc:spChg>
        <pc:spChg chg="del">
          <ac:chgData name="Lise Denoeud" userId="2ae5119a-4b99-4d54-9205-1fb18db3d132" providerId="ADAL" clId="{FC7DF5A0-6F98-4166-9574-1EC73A50F3A5}" dt="2022-12-07T09:15:31.937" v="11" actId="478"/>
          <ac:spMkLst>
            <pc:docMk/>
            <pc:sldMk cId="724398003" sldId="257"/>
            <ac:spMk id="3" creationId="{FFCD9153-6D71-4512-ACCA-37EE778FAC54}"/>
          </ac:spMkLst>
        </pc:spChg>
        <pc:spChg chg="add del mod">
          <ac:chgData name="Lise Denoeud" userId="2ae5119a-4b99-4d54-9205-1fb18db3d132" providerId="ADAL" clId="{FC7DF5A0-6F98-4166-9574-1EC73A50F3A5}" dt="2022-12-07T09:18:22.651" v="191"/>
          <ac:spMkLst>
            <pc:docMk/>
            <pc:sldMk cId="724398003" sldId="257"/>
            <ac:spMk id="4" creationId="{1FF0B62C-7C87-451C-B113-6142A343865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D26C2-257C-46F1-96A5-88B7853E7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9221A7-0B12-4F1C-ACE4-E07F038CDC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40EFCB-EC88-4338-A399-699B0CEA8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F53F6-3A1F-4057-B9F0-56DAB8328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FD7840-439B-4E7E-A7FF-34AF9E73A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843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72E10-00C3-46BC-9B56-20CAC12FC9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CC6019-5C48-468B-952F-DF10F66717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CDDAE0-1820-4847-A028-A2FB801F21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D2CC1B-238C-4C57-BCE5-209174A8B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3AC996-578E-4801-B6B8-4E38B9409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738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C25259-59FD-41DB-8F6D-60FA337C60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963833-4868-41F7-899C-028F683FF0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6BE38E-6C1D-4A78-97FD-8E52BF10B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EA7E89-09D0-4891-AE38-0F8512434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7CDC07-4771-4B8B-929F-40EC26D07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373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30AA54-1079-4442-9D27-692CB4D20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52A999-730D-4747-BF99-4753CF7E98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25548-71BD-4669-950F-F3E7629B8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B763F7-BFD6-458A-AC94-95A76650D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B5BA2C-70C7-4BB2-9891-6206FB049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550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73773-F103-414B-8364-946485EB1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7B1B08-A47F-433D-8EA2-572F7FD988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AE1405-9619-4C4C-BF02-1870268DD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43C166-C41C-490C-B94B-40ADC00B0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34061D-C331-49CF-B148-7BAE25560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577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AD0A2D-7DBD-4A86-9593-E3F7E939B8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8A85BB-D82F-4B3F-9C98-1A2E63C3AC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73EF21-8FE9-472C-BF76-821FB085A3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3D8872-2133-4237-9317-C1F131F0F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E36F45-A47C-42C7-9E7A-16EADD889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22737D-4E6C-485F-87AD-564662061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116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879417-FA45-403D-8CC5-343513BB0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914D2F-4D6E-4AB0-86BF-B6080EF1E0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54BBC6-9136-434D-8433-E9E881A7E4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8FDBBB-2AFE-489C-BEF6-F9EAF4BC48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7AC539-A5C5-47DC-9A09-DFA8C5265F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645EF2-982B-41DC-9BF0-EE0CC318A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872439-F0F6-4C44-BA5A-01B5E0130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14F7B0-DC1B-472E-BB33-897AFB616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092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FA348C-C9DF-47D7-8F70-8AB2E68B06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CD84EF-0079-483E-B325-91098D07D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41D83C-AA6E-4DA1-9F79-463DB1B50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46D33E-EC01-4AB2-B45E-28A6BAB08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77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D01E6F6-34F4-4972-869C-4ECED62DA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B3F836B-0C79-4988-BE80-81EFE3237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007D7D-74FC-4917-9DD9-BE6D12F88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326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3933D-F419-4944-B7B0-BC83F2647D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4E1D46-C083-4CEA-B850-92909E500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8B4095-7EEC-49BF-B2B5-D27BB5B806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F00138-82F6-48BE-A753-008C28B9D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6E70F2-1E94-486F-A52F-173606064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4D9976-B350-4365-82B3-6E1C0805D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212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F0F00D-777F-4DA4-8120-FA23EB3F1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74D26F-39A5-46A4-918B-064CCFD789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58F835-9978-4FFC-BA27-A112FA56DE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E7DCFD-AFC7-4613-BFFB-DD6F5F655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5C1D18-E900-4FD3-AFC8-E50A89959B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80A86A-77CE-42CF-A1CF-1D5B952B9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427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371F11-4E33-4745-BF6F-CBBCFFAFD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FB20D0-0BB4-4E15-824C-C33C7EF220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4C68D-140E-481D-B547-744F2C5601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7E918-7657-4A0A-ADF7-9676170F33EE}" type="datetimeFigureOut">
              <a:rPr lang="en-US" smtClean="0"/>
              <a:t>12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17ACA9-34CE-44C2-AFD6-A0934715C2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29F956-0BB8-4D15-B57A-D20FF9C67F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C5BAB-3AE8-44BE-B61A-2C889AEEA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74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13E8827-6AF7-4052-A99C-721C96F21DBC}"/>
              </a:ext>
            </a:extLst>
          </p:cNvPr>
          <p:cNvSpPr/>
          <p:nvPr/>
        </p:nvSpPr>
        <p:spPr>
          <a:xfrm>
            <a:off x="5368774" y="866630"/>
            <a:ext cx="2155971" cy="1056299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dirty="0"/>
              <a:t>Children &lt;5 years old with presumptive TB </a:t>
            </a:r>
          </a:p>
          <a:p>
            <a:pPr lvl="0" algn="ctr"/>
            <a:r>
              <a:rPr lang="en-US" dirty="0"/>
              <a:t>n=790 </a:t>
            </a:r>
          </a:p>
          <a:p>
            <a:pPr lvl="0" algn="ctr"/>
            <a:r>
              <a:rPr lang="en-US" i="1" dirty="0"/>
              <a:t>Enrolled in INPUT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2F13B4F-E9DE-4972-89AD-0EF96656586D}"/>
              </a:ext>
            </a:extLst>
          </p:cNvPr>
          <p:cNvSpPr/>
          <p:nvPr/>
        </p:nvSpPr>
        <p:spPr>
          <a:xfrm>
            <a:off x="2574190" y="891444"/>
            <a:ext cx="2222384" cy="1006669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HIV-infected</a:t>
            </a:r>
          </a:p>
          <a:p>
            <a:pPr algn="ctr"/>
            <a:r>
              <a:rPr lang="en-US" dirty="0"/>
              <a:t>n=53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167C8C2-10A1-4BBE-963F-A60764812273}"/>
              </a:ext>
            </a:extLst>
          </p:cNvPr>
          <p:cNvSpPr/>
          <p:nvPr/>
        </p:nvSpPr>
        <p:spPr>
          <a:xfrm>
            <a:off x="2574190" y="2117305"/>
            <a:ext cx="2222383" cy="1006668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HIV-uninfected or unknown</a:t>
            </a:r>
          </a:p>
          <a:p>
            <a:pPr algn="ctr"/>
            <a:r>
              <a:rPr lang="en-US" dirty="0"/>
              <a:t>n=737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6F95602-531B-49C4-8EEA-004C788006A1}"/>
              </a:ext>
            </a:extLst>
          </p:cNvPr>
          <p:cNvSpPr/>
          <p:nvPr/>
        </p:nvSpPr>
        <p:spPr>
          <a:xfrm>
            <a:off x="5368774" y="3661905"/>
            <a:ext cx="2155971" cy="1106637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dirty="0"/>
              <a:t>Children with bacteriologic or clinical TB diagnosis </a:t>
            </a:r>
          </a:p>
          <a:p>
            <a:pPr lvl="0" algn="ctr"/>
            <a:r>
              <a:rPr lang="en-US" dirty="0"/>
              <a:t>n=157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16C00CA-F73B-4709-A3EC-56332F9B9E2E}"/>
              </a:ext>
            </a:extLst>
          </p:cNvPr>
          <p:cNvSpPr/>
          <p:nvPr/>
        </p:nvSpPr>
        <p:spPr>
          <a:xfrm>
            <a:off x="7689729" y="2050893"/>
            <a:ext cx="2155970" cy="1302373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dirty="0"/>
              <a:t>Children &lt;5 years old with TB diagnosis ruled out</a:t>
            </a:r>
          </a:p>
          <a:p>
            <a:pPr lvl="0" algn="ctr"/>
            <a:r>
              <a:rPr lang="en-US" dirty="0"/>
              <a:t>n=633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E9DCA5A-2C2B-41F7-8449-BBB3FE1BF10B}"/>
              </a:ext>
            </a:extLst>
          </p:cNvPr>
          <p:cNvSpPr/>
          <p:nvPr/>
        </p:nvSpPr>
        <p:spPr>
          <a:xfrm>
            <a:off x="3558155" y="5674879"/>
            <a:ext cx="2155970" cy="982902"/>
          </a:xfrm>
          <a:prstGeom prst="rect">
            <a:avLst/>
          </a:prstGeom>
          <a:gradFill>
            <a:gsLst>
              <a:gs pos="0">
                <a:schemeClr val="accent2"/>
              </a:gs>
              <a:gs pos="100000">
                <a:schemeClr val="accent1"/>
              </a:gs>
              <a:gs pos="100000">
                <a:schemeClr val="accent1"/>
              </a:gs>
              <a:gs pos="100000">
                <a:schemeClr val="accent5"/>
              </a:gs>
            </a:gsLst>
            <a:lin ang="540000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dirty="0"/>
              <a:t>With TB and HIV-infected</a:t>
            </a:r>
          </a:p>
          <a:p>
            <a:pPr lvl="0" algn="ctr"/>
            <a:r>
              <a:rPr lang="en-US" dirty="0"/>
              <a:t>n=22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08E08BA-A59C-4F75-8633-781C036E7249}"/>
              </a:ext>
            </a:extLst>
          </p:cNvPr>
          <p:cNvSpPr/>
          <p:nvPr/>
        </p:nvSpPr>
        <p:spPr>
          <a:xfrm>
            <a:off x="7068244" y="5665304"/>
            <a:ext cx="2155971" cy="98290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dirty="0"/>
              <a:t>With TB and HIV-uninfected/unknown</a:t>
            </a:r>
          </a:p>
          <a:p>
            <a:pPr lvl="0" algn="ctr"/>
            <a:r>
              <a:rPr lang="en-US" dirty="0"/>
              <a:t>n=135</a:t>
            </a:r>
          </a:p>
        </p:txBody>
      </p:sp>
      <p:cxnSp>
        <p:nvCxnSpPr>
          <p:cNvPr id="14" name="Connector: Elbow 13">
            <a:extLst>
              <a:ext uri="{FF2B5EF4-FFF2-40B4-BE49-F238E27FC236}">
                <a16:creationId xmlns:a16="http://schemas.microsoft.com/office/drawing/2014/main" id="{95E4544F-7523-4F54-BF09-8B3D5A1A8FAC}"/>
              </a:ext>
            </a:extLst>
          </p:cNvPr>
          <p:cNvCxnSpPr>
            <a:cxnSpLocks/>
            <a:stCxn id="4" idx="1"/>
            <a:endCxn id="6" idx="3"/>
          </p:cNvCxnSpPr>
          <p:nvPr/>
        </p:nvCxnSpPr>
        <p:spPr>
          <a:xfrm rot="10800000" flipV="1">
            <a:off x="4796574" y="1394779"/>
            <a:ext cx="572201" cy="1225859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D77782D4-881F-4B94-8B32-6403807E74D8}"/>
              </a:ext>
            </a:extLst>
          </p:cNvPr>
          <p:cNvCxnSpPr>
            <a:cxnSpLocks/>
            <a:stCxn id="4" idx="1"/>
            <a:endCxn id="5" idx="3"/>
          </p:cNvCxnSpPr>
          <p:nvPr/>
        </p:nvCxnSpPr>
        <p:spPr>
          <a:xfrm flipH="1" flipV="1">
            <a:off x="4796574" y="1394779"/>
            <a:ext cx="572200" cy="1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or: Elbow 27">
            <a:extLst>
              <a:ext uri="{FF2B5EF4-FFF2-40B4-BE49-F238E27FC236}">
                <a16:creationId xmlns:a16="http://schemas.microsoft.com/office/drawing/2014/main" id="{6EFAEDA9-97F6-4F9F-9A32-A24DB6C4911A}"/>
              </a:ext>
            </a:extLst>
          </p:cNvPr>
          <p:cNvCxnSpPr>
            <a:cxnSpLocks/>
            <a:stCxn id="7" idx="2"/>
            <a:endCxn id="9" idx="0"/>
          </p:cNvCxnSpPr>
          <p:nvPr/>
        </p:nvCxnSpPr>
        <p:spPr>
          <a:xfrm rot="5400000">
            <a:off x="5088282" y="4316400"/>
            <a:ext cx="906337" cy="1810620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or: Elbow 29">
            <a:extLst>
              <a:ext uri="{FF2B5EF4-FFF2-40B4-BE49-F238E27FC236}">
                <a16:creationId xmlns:a16="http://schemas.microsoft.com/office/drawing/2014/main" id="{D5683480-6363-46BA-87D3-48B7D1A8112B}"/>
              </a:ext>
            </a:extLst>
          </p:cNvPr>
          <p:cNvCxnSpPr>
            <a:cxnSpLocks/>
            <a:stCxn id="7" idx="2"/>
            <a:endCxn id="10" idx="0"/>
          </p:cNvCxnSpPr>
          <p:nvPr/>
        </p:nvCxnSpPr>
        <p:spPr>
          <a:xfrm rot="16200000" flipH="1">
            <a:off x="6848114" y="4367188"/>
            <a:ext cx="896762" cy="1699470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5DDC0D79-926B-4C3F-91DE-82F933F1556D}"/>
              </a:ext>
            </a:extLst>
          </p:cNvPr>
          <p:cNvCxnSpPr>
            <a:cxnSpLocks/>
            <a:endCxn id="7" idx="0"/>
          </p:cNvCxnSpPr>
          <p:nvPr/>
        </p:nvCxnSpPr>
        <p:spPr>
          <a:xfrm>
            <a:off x="6446760" y="1898113"/>
            <a:ext cx="0" cy="1763792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1E6B1159-768D-4EFB-84C3-D89F05387384}"/>
              </a:ext>
            </a:extLst>
          </p:cNvPr>
          <p:cNvCxnSpPr>
            <a:cxnSpLocks/>
            <a:endCxn id="8" idx="1"/>
          </p:cNvCxnSpPr>
          <p:nvPr/>
        </p:nvCxnSpPr>
        <p:spPr>
          <a:xfrm>
            <a:off x="6446759" y="2702080"/>
            <a:ext cx="1242970" cy="0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35EFC873-B0AD-4CED-81C8-B8A6B6ED3A05}"/>
              </a:ext>
            </a:extLst>
          </p:cNvPr>
          <p:cNvSpPr txBox="1"/>
          <p:nvPr/>
        </p:nvSpPr>
        <p:spPr>
          <a:xfrm>
            <a:off x="2143040" y="141231"/>
            <a:ext cx="754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dditional file 1. HIV and TB status of children enrolled in INPUT study</a:t>
            </a:r>
          </a:p>
        </p:txBody>
      </p:sp>
    </p:spTree>
    <p:extLst>
      <p:ext uri="{BB962C8B-B14F-4D97-AF65-F5344CB8AC3E}">
        <p14:creationId xmlns:p14="http://schemas.microsoft.com/office/powerpoint/2010/main" val="1432623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331BFD2383F21409D772429AB4D3AC8" ma:contentTypeVersion="13" ma:contentTypeDescription="Create a new document." ma:contentTypeScope="" ma:versionID="6ab4e6f4544ff730aad42e84152e7ece">
  <xsd:schema xmlns:xsd="http://www.w3.org/2001/XMLSchema" xmlns:xs="http://www.w3.org/2001/XMLSchema" xmlns:p="http://schemas.microsoft.com/office/2006/metadata/properties" xmlns:ns3="b5cd6bcb-cc9a-42d8-b128-8d5af402f831" xmlns:ns4="a782095d-6c8e-4d5f-9247-112fb09edbce" targetNamespace="http://schemas.microsoft.com/office/2006/metadata/properties" ma:root="true" ma:fieldsID="356f18675bd8b319ca035e36f0d241d5" ns3:_="" ns4:_="">
    <xsd:import namespace="b5cd6bcb-cc9a-42d8-b128-8d5af402f831"/>
    <xsd:import namespace="a782095d-6c8e-4d5f-9247-112fb09edbc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5cd6bcb-cc9a-42d8-b128-8d5af402f8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782095d-6c8e-4d5f-9247-112fb09edbc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944278D-4848-4E99-8E60-A86FF6765428}">
  <ds:schemaRefs>
    <ds:schemaRef ds:uri="a782095d-6c8e-4d5f-9247-112fb09edbce"/>
    <ds:schemaRef ds:uri="http://purl.org/dc/dcmitype/"/>
    <ds:schemaRef ds:uri="http://www.w3.org/XML/1998/namespace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openxmlformats.org/package/2006/metadata/core-properties"/>
    <ds:schemaRef ds:uri="b5cd6bcb-cc9a-42d8-b128-8d5af402f831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B7F96660-6C29-49B4-B6A4-7D9A05E7B87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B6DC5FE-701A-47EE-AC3C-F9CF40E9493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5cd6bcb-cc9a-42d8-b128-8d5af402f831"/>
    <ds:schemaRef ds:uri="a782095d-6c8e-4d5f-9247-112fb09edbc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60</TotalTime>
  <Words>7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e Denoeud</dc:creator>
  <cp:lastModifiedBy>Lise Denoeud</cp:lastModifiedBy>
  <cp:revision>3</cp:revision>
  <dcterms:created xsi:type="dcterms:W3CDTF">2022-10-27T15:33:29Z</dcterms:created>
  <dcterms:modified xsi:type="dcterms:W3CDTF">2022-12-07T09:45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331BFD2383F21409D772429AB4D3AC8</vt:lpwstr>
  </property>
</Properties>
</file>